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31" d="100"/>
          <a:sy n="131" d="100"/>
        </p:scale>
        <p:origin x="-112" y="-57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94AAF-B3D4-FB4B-A703-84F3FBCA2184}" type="datetimeFigureOut">
              <a:rPr lang="en-US" smtClean="0"/>
              <a:t>8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BFBF6-3CAB-2E42-9411-373C6A316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78019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94AAF-B3D4-FB4B-A703-84F3FBCA2184}" type="datetimeFigureOut">
              <a:rPr lang="en-US" smtClean="0"/>
              <a:t>8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BFBF6-3CAB-2E42-9411-373C6A316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0985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94AAF-B3D4-FB4B-A703-84F3FBCA2184}" type="datetimeFigureOut">
              <a:rPr lang="en-US" smtClean="0"/>
              <a:t>8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BFBF6-3CAB-2E42-9411-373C6A316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41752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94AAF-B3D4-FB4B-A703-84F3FBCA2184}" type="datetimeFigureOut">
              <a:rPr lang="en-US" smtClean="0"/>
              <a:t>8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BFBF6-3CAB-2E42-9411-373C6A316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32940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94AAF-B3D4-FB4B-A703-84F3FBCA2184}" type="datetimeFigureOut">
              <a:rPr lang="en-US" smtClean="0"/>
              <a:t>8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BFBF6-3CAB-2E42-9411-373C6A316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51170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94AAF-B3D4-FB4B-A703-84F3FBCA2184}" type="datetimeFigureOut">
              <a:rPr lang="en-US" smtClean="0"/>
              <a:t>8/1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BFBF6-3CAB-2E42-9411-373C6A316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15573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94AAF-B3D4-FB4B-A703-84F3FBCA2184}" type="datetimeFigureOut">
              <a:rPr lang="en-US" smtClean="0"/>
              <a:t>8/17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BFBF6-3CAB-2E42-9411-373C6A316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4009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94AAF-B3D4-FB4B-A703-84F3FBCA2184}" type="datetimeFigureOut">
              <a:rPr lang="en-US" smtClean="0"/>
              <a:t>8/17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BFBF6-3CAB-2E42-9411-373C6A316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67186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94AAF-B3D4-FB4B-A703-84F3FBCA2184}" type="datetimeFigureOut">
              <a:rPr lang="en-US" smtClean="0"/>
              <a:t>8/17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BFBF6-3CAB-2E42-9411-373C6A316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1641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94AAF-B3D4-FB4B-A703-84F3FBCA2184}" type="datetimeFigureOut">
              <a:rPr lang="en-US" smtClean="0"/>
              <a:t>8/1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BFBF6-3CAB-2E42-9411-373C6A316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0109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94AAF-B3D4-FB4B-A703-84F3FBCA2184}" type="datetimeFigureOut">
              <a:rPr lang="en-US" smtClean="0"/>
              <a:t>8/1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BFBF6-3CAB-2E42-9411-373C6A316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76281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E94AAF-B3D4-FB4B-A703-84F3FBCA2184}" type="datetimeFigureOut">
              <a:rPr lang="en-US" smtClean="0"/>
              <a:t>8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2BFBF6-3CAB-2E42-9411-373C6A316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95476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9.png"/><Relationship Id="rId3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8161" y="703808"/>
            <a:ext cx="7964248" cy="6154191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53415" y="103005"/>
            <a:ext cx="27571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Supplementary Figure </a:t>
            </a:r>
            <a:r>
              <a:rPr lang="en-US" sz="1600" dirty="0"/>
              <a:t>1</a:t>
            </a:r>
            <a:r>
              <a:rPr lang="en-US" sz="1600" dirty="0" smtClean="0"/>
              <a:t>. 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26789354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153415" y="103005"/>
            <a:ext cx="27571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Supplementary Figure 2. </a:t>
            </a:r>
            <a:endParaRPr lang="en-US" sz="1600" dirty="0"/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3323" y="2613934"/>
            <a:ext cx="2293931" cy="2011680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37338" y="2613934"/>
            <a:ext cx="2293931" cy="2011680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39229" y="619577"/>
            <a:ext cx="2293931" cy="2011680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37338" y="619577"/>
            <a:ext cx="2293931" cy="2011680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781937" y="602254"/>
            <a:ext cx="2293931" cy="2011680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639229" y="2613934"/>
            <a:ext cx="2293931" cy="2011680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23323" y="619577"/>
            <a:ext cx="2293931" cy="20116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586316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439453"/>
            <a:ext cx="8229600" cy="481615"/>
          </a:xfrm>
        </p:spPr>
        <p:txBody>
          <a:bodyPr>
            <a:normAutofit/>
          </a:bodyPr>
          <a:lstStyle/>
          <a:p>
            <a:r>
              <a:rPr lang="en-US" sz="2400" dirty="0" smtClean="0"/>
              <a:t>Correlations of THCA with NS1D1 in TCGA THCA</a:t>
            </a:r>
            <a:endParaRPr lang="en-US" sz="2400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7200" y="3641031"/>
            <a:ext cx="4682659" cy="27432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9121" y="892878"/>
            <a:ext cx="4682660" cy="27432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5993726" y="1840691"/>
            <a:ext cx="216915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earson </a:t>
            </a:r>
            <a:r>
              <a:rPr lang="en-US" dirty="0" err="1" smtClean="0"/>
              <a:t>cor</a:t>
            </a:r>
            <a:r>
              <a:rPr lang="en-US" dirty="0" smtClean="0"/>
              <a:t>=-0.09, p=0.04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6146126" y="4357189"/>
            <a:ext cx="216915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earson </a:t>
            </a:r>
            <a:r>
              <a:rPr lang="en-US" dirty="0" err="1" smtClean="0"/>
              <a:t>cor</a:t>
            </a:r>
            <a:r>
              <a:rPr lang="en-US" dirty="0" smtClean="0"/>
              <a:t>=-0.16, p=0.24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230996" y="159896"/>
            <a:ext cx="20567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Supplementary fig3.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10296888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37</Words>
  <Application>Microsoft Macintosh PowerPoint</Application>
  <PresentationFormat>On-screen Show (4:3)</PresentationFormat>
  <Paragraphs>6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Correlations of THCA with NS1D1 in TCGA THCA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brennan</dc:creator>
  <cp:lastModifiedBy>kbrennan</cp:lastModifiedBy>
  <cp:revision>2</cp:revision>
  <dcterms:created xsi:type="dcterms:W3CDTF">2016-08-17T22:46:12Z</dcterms:created>
  <dcterms:modified xsi:type="dcterms:W3CDTF">2016-08-17T22:53:40Z</dcterms:modified>
</cp:coreProperties>
</file>